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262" r:id="rId2"/>
    <p:sldId id="261" r:id="rId3"/>
    <p:sldId id="264" r:id="rId4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ing, Jun" initials="YJ" lastIdx="6" clrIdx="0">
    <p:extLst>
      <p:ext uri="{19B8F6BF-5375-455C-9EA6-DF929625EA0E}">
        <p15:presenceInfo xmlns:p15="http://schemas.microsoft.com/office/powerpoint/2012/main" userId="S-1-5-21-45967694-370826977-176895030-3357342" providerId="AD"/>
      </p:ext>
    </p:extLst>
  </p:cmAuthor>
  <p:cmAuthor id="2" name="Wong, Henry K" initials="WHK" lastIdx="1" clrIdx="1">
    <p:extLst>
      <p:ext uri="{19B8F6BF-5375-455C-9EA6-DF929625EA0E}">
        <p15:presenceInfo xmlns:p15="http://schemas.microsoft.com/office/powerpoint/2012/main" userId="S-1-5-21-45967694-370826977-176895030-21143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7BBE0"/>
    <a:srgbClr val="9B9DB7"/>
    <a:srgbClr val="C1C3DF"/>
    <a:srgbClr val="D4BBD9"/>
    <a:srgbClr val="AAADC6"/>
    <a:srgbClr val="B9A9A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341"/>
    <p:restoredTop sz="84129" autoAdjust="0"/>
  </p:normalViewPr>
  <p:slideViewPr>
    <p:cSldViewPr snapToGrid="0">
      <p:cViewPr>
        <p:scale>
          <a:sx n="100" d="100"/>
          <a:sy n="100" d="100"/>
        </p:scale>
        <p:origin x="912" y="-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11" Type="http://schemas.openxmlformats.org/officeDocument/2006/relationships/tableStyles" Target="tableStyles.xml"/><Relationship Id="rId5" Type="http://schemas.openxmlformats.org/officeDocument/2006/relationships/notesMaster" Target="notesMasters/notesMaster1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2B53FB81-C39E-499B-99E5-E9E33496C3EA}" type="datetimeFigureOut">
              <a:rPr lang="en-US" smtClean="0"/>
              <a:t>7/17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DC39B0AB-F4ED-4969-AE4A-80CBBF8899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02603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A1004D-8486-4DEF-8966-E8FF873550D6}" type="datetimeFigureOut">
              <a:rPr lang="en-US" smtClean="0"/>
              <a:t>7/17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297615-4B39-44BA-832A-B5E06D8117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8682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297615-4B39-44BA-832A-B5E06D8117B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4829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7B2B7C-E04F-825F-70C1-1B739B083F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9B89477-F4D0-77FD-26A4-80BCDDB54E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534390-F711-4094-9FD5-2395BF37E7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C5FB2-9FA7-E347-91F1-0A6691BC5C58}" type="datetimeFigureOut">
              <a:rPr lang="en-US" smtClean="0"/>
              <a:t>7/1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784D5F-07E4-3330-3B40-7D77AE140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E1CFC4-D546-3D81-9E25-F3DC1E54C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73916-6922-DC4D-AE26-BCB5E3281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58037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FC7C09-036C-2F55-F32E-D694D91E90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E4A4E9F-C262-EC66-37C6-B4E86E3EE1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22957D-0728-3A1B-73D9-F2FCC03898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C5FB2-9FA7-E347-91F1-0A6691BC5C58}" type="datetimeFigureOut">
              <a:rPr lang="en-US" smtClean="0"/>
              <a:t>7/1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5509B0-6A64-1732-9B5B-851C8A180B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38A3EC-850D-8F39-ACA2-99F931FB1E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73916-6922-DC4D-AE26-BCB5E3281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69195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38E1B44-3532-A391-601A-3F22C566D4D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6C0C6FD-C634-9E2C-883E-AB47AF5A64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35ED68-F5D1-3CFC-4CBE-3F57DA9624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C5FB2-9FA7-E347-91F1-0A6691BC5C58}" type="datetimeFigureOut">
              <a:rPr lang="en-US" smtClean="0"/>
              <a:t>7/1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7AFE9C-0B9A-30FA-7CF8-2E4A5928CA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A2A00C-8491-98CE-93BD-74F7365762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73916-6922-DC4D-AE26-BCB5E3281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3725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EA2FC4-9B05-B293-FCC6-5E95671711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74951B-D1A5-E75E-7357-9951FC361F6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D8D4E5-A696-6CFD-6FE8-E4416C0847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C5FB2-9FA7-E347-91F1-0A6691BC5C58}" type="datetimeFigureOut">
              <a:rPr lang="en-US" smtClean="0"/>
              <a:t>7/1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1A384F-07E7-2E91-7974-16BFF0EA44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0A61C6-5F44-26A7-6C5D-BF3C90E0A7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73916-6922-DC4D-AE26-BCB5E3281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9778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6A18B4-8EE8-4F1F-85A1-CC5DCA94E3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D3E85E-48B6-3DE9-1213-3EB6EB5C5D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1C7E32-52B7-D629-8A80-9AC6E5692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C5FB2-9FA7-E347-91F1-0A6691BC5C58}" type="datetimeFigureOut">
              <a:rPr lang="en-US" smtClean="0"/>
              <a:t>7/1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36CA8D-4342-C4BC-C859-DB9394FB36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C1E5DD-763F-9CC2-78D6-D29B4A06F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73916-6922-DC4D-AE26-BCB5E3281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35934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F85789-26A0-EE3A-D811-1B8D86410D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C55F10-E7A1-8528-D460-3B0FC1EE23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9273FC-2A85-5167-1707-4F4D1E2A33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8847AA-188E-A754-0521-DA1638BD25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C5FB2-9FA7-E347-91F1-0A6691BC5C58}" type="datetimeFigureOut">
              <a:rPr lang="en-US" smtClean="0"/>
              <a:t>7/17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365178-E94C-5EC7-5AF3-C1F76D4A6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C2C0A2-A4CD-EFC9-9245-BDAFC58F96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73916-6922-DC4D-AE26-BCB5E3281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048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F13C7C-1A1A-C509-EFC7-228E4A6346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A7A2DF-6BBF-6530-67A6-5159CC8375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7789CA0-F85F-EDD6-C2B5-F32786048E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5BB55DD-FC0F-EEA9-1C4E-8FBFABD47D3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8C3631D-2194-5646-C6FB-ED8261E986F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D2E46B0-CE3C-556F-FCAC-E0070BB7DD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C5FB2-9FA7-E347-91F1-0A6691BC5C58}" type="datetimeFigureOut">
              <a:rPr lang="en-US" smtClean="0"/>
              <a:t>7/17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093B5C3-2B80-2299-97AF-EFE6024D26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DA7BF2B-2DD6-8DF9-78F3-A9DDEC0DE0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73916-6922-DC4D-AE26-BCB5E3281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7390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CE0A94-D34D-69A4-CEF1-156BB75A28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E774A37-04E0-97D4-D33A-0168661758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C5FB2-9FA7-E347-91F1-0A6691BC5C58}" type="datetimeFigureOut">
              <a:rPr lang="en-US" smtClean="0"/>
              <a:t>7/17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7E37EB8-249B-DAA7-B35C-971C9AF2E7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07AF329-F152-2A7B-0183-E75A8B6928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73916-6922-DC4D-AE26-BCB5E3281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01398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50CF36D-56B3-679D-986B-22E0C27D42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C5FB2-9FA7-E347-91F1-0A6691BC5C58}" type="datetimeFigureOut">
              <a:rPr lang="en-US" smtClean="0"/>
              <a:t>7/17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B3E9916-0D5F-2922-0E8F-D1BF7FF7E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3808A65-4FF8-AB32-7375-AC63CBDB50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73916-6922-DC4D-AE26-BCB5E3281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1496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868B76-7CEF-B917-692C-6C357B8F07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CCAFC3-2150-4DC9-0D39-AFB816ECFE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B5FD04-1520-19AD-58F3-25DF250E93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A3450A-A2E0-8430-5DF3-D5313BBC0C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C5FB2-9FA7-E347-91F1-0A6691BC5C58}" type="datetimeFigureOut">
              <a:rPr lang="en-US" smtClean="0"/>
              <a:t>7/17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E5080C-C680-262B-0956-6CAF2973AC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66B680-0AEC-9758-6465-85067C3061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73916-6922-DC4D-AE26-BCB5E3281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434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39B869-3A49-207C-4BD5-09EA3A8A96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D5D253A-DEAA-6E50-9956-B398F0EA252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6C7C62C-C257-8FD1-7869-82462FC199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BB2F70-3DEE-0940-5FC8-35C0C585F8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C5FB2-9FA7-E347-91F1-0A6691BC5C58}" type="datetimeFigureOut">
              <a:rPr lang="en-US" smtClean="0"/>
              <a:t>7/17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CFF1ED-F643-BF57-6BFB-3C623CF8DD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1C7E2C4-710F-CD02-2151-D4E48ED240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73916-6922-DC4D-AE26-BCB5E3281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410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E3967FD-630B-5731-7F7C-4867753A1D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D08C1F-F436-34D6-1855-D87766D20E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7B0BA9-A30B-5B5E-5713-4A56E3DE179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1C5FB2-9FA7-E347-91F1-0A6691BC5C58}" type="datetimeFigureOut">
              <a:rPr lang="en-US" smtClean="0"/>
              <a:t>7/1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CF1284-C8A4-0D61-E118-05E8D89868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40B2DD-D591-B896-B57D-03DAAC252CC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D73916-6922-DC4D-AE26-BCB5E3281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7914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D65E62-AC66-22AF-5952-815712FDD0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039533" y="2351969"/>
            <a:ext cx="5675489" cy="1325563"/>
          </a:xfrm>
        </p:spPr>
        <p:txBody>
          <a:bodyPr/>
          <a:lstStyle/>
          <a:p>
            <a:r>
              <a:rPr lang="en-US" dirty="0"/>
              <a:t>Supplementary Tables</a:t>
            </a:r>
            <a:br>
              <a:rPr lang="en-US" dirty="0"/>
            </a:b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7117003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E1802A8F-2D4E-24BA-D05E-3BE73EC9A1C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21988448"/>
              </p:ext>
            </p:extLst>
          </p:nvPr>
        </p:nvGraphicFramePr>
        <p:xfrm>
          <a:off x="1724025" y="1028347"/>
          <a:ext cx="8743950" cy="4972046"/>
        </p:xfrm>
        <a:graphic>
          <a:graphicData uri="http://schemas.openxmlformats.org/drawingml/2006/table">
            <a:tbl>
              <a:tblPr/>
              <a:tblGrid>
                <a:gridCol w="1194074">
                  <a:extLst>
                    <a:ext uri="{9D8B030D-6E8A-4147-A177-3AD203B41FA5}">
                      <a16:colId xmlns:a16="http://schemas.microsoft.com/office/drawing/2014/main" val="1150965016"/>
                    </a:ext>
                  </a:extLst>
                </a:gridCol>
                <a:gridCol w="3616232">
                  <a:extLst>
                    <a:ext uri="{9D8B030D-6E8A-4147-A177-3AD203B41FA5}">
                      <a16:colId xmlns:a16="http://schemas.microsoft.com/office/drawing/2014/main" val="3281292478"/>
                    </a:ext>
                  </a:extLst>
                </a:gridCol>
                <a:gridCol w="3933644">
                  <a:extLst>
                    <a:ext uri="{9D8B030D-6E8A-4147-A177-3AD203B41FA5}">
                      <a16:colId xmlns:a16="http://schemas.microsoft.com/office/drawing/2014/main" val="107222571"/>
                    </a:ext>
                  </a:extLst>
                </a:gridCol>
              </a:tblGrid>
              <a:tr h="3218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 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rward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vers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0362695"/>
                  </a:ext>
                </a:extLst>
              </a:tr>
              <a:tr h="2735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2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TACTTTGAGTGCTGTCTCCATG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AGTTGCCAGCCCTCCTAGA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9000787"/>
                  </a:ext>
                </a:extLst>
              </a:tr>
              <a:tr h="2735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NM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TTCTCACTTCTGGTTGGAGG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GTAGCAGACAAGGCAAGTG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06664275"/>
                  </a:ext>
                </a:extLst>
              </a:tr>
              <a:tr h="2735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CRL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GAGATAGCAACCCGATTTATT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GTAAGTTCCTCATGCTCTTGAT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16763003"/>
                  </a:ext>
                </a:extLst>
              </a:tr>
              <a:tr h="2735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TA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TGGAGGAGGAATGCCAA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GGGTTAAACGAGCTGTT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3857242"/>
                  </a:ext>
                </a:extLst>
              </a:tr>
              <a:tr h="2735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NG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CACTAGCATCTCCCAAG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GTTTTCTGATGCAGGCAC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4401108"/>
                  </a:ext>
                </a:extLst>
              </a:tr>
              <a:tr h="2735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ACCATTGTAGAATTTCTGAACA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GATATGTTTTAAGTGGGAAGCAC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3094114"/>
                  </a:ext>
                </a:extLst>
              </a:tr>
              <a:tr h="2735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GTTCTACAGCCACCATGA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TTTCAGGAATCGGATCAG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29860584"/>
                  </a:ext>
                </a:extLst>
              </a:tr>
              <a:tr h="2735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GCGCTGTCATCGATTTCT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GCTTTGTAGATGCCTTTCTCTT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547402"/>
                  </a:ext>
                </a:extLst>
              </a:tr>
              <a:tr h="2735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TCATTATTTGCAGAGACAGGA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CAGGCTGAGGTCTAA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3681027"/>
                  </a:ext>
                </a:extLst>
              </a:tr>
              <a:tr h="2735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17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CGATCCACCTCACCTTG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CACGTTCCCATCAGCGT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019539"/>
                  </a:ext>
                </a:extLst>
              </a:tr>
              <a:tr h="2735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K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GGATCACGTGTTACCTGCTAC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TCATGGAGTTCACAGAAGGT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5058881"/>
                  </a:ext>
                </a:extLst>
              </a:tr>
              <a:tr h="2735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DD4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CTTAGTCACCTTCCGAC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AACTTCCCATCCATGCTC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4154348"/>
                  </a:ext>
                </a:extLst>
              </a:tr>
              <a:tr h="2735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S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GGAACCAAACCCTGACTT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TCTTCCAGGACATTGAGGGTA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12370816"/>
                  </a:ext>
                </a:extLst>
              </a:tr>
              <a:tr h="2735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T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ATGGTCACCTCACCTGG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AGCCGTTCCTTCTCTTTG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90750334"/>
                  </a:ext>
                </a:extLst>
              </a:tr>
              <a:tr h="2735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WIST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AGATTCAGACCCTCAAGC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GCTCTGGAGGACCTGGT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48165102"/>
                  </a:ext>
                </a:extLst>
              </a:tr>
              <a:tr h="2735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X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ACTCAGGCCGCCATCAA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TCGCCAAAGGTAGCGTT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4041150"/>
                  </a:ext>
                </a:extLst>
              </a:tr>
              <a:tr h="2735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IGI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GGTGCCAGGTTCCAGAT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GCTCCATTCCTCCTGTCC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5600088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08E19DC9-B529-C965-2779-E9DCA74A0FAE}"/>
              </a:ext>
            </a:extLst>
          </p:cNvPr>
          <p:cNvSpPr txBox="1"/>
          <p:nvPr/>
        </p:nvSpPr>
        <p:spPr>
          <a:xfrm>
            <a:off x="1229739" y="719107"/>
            <a:ext cx="67769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Supplementary Table S1: Oligonucleotide primers for PCR of SS biomarker genes.</a:t>
            </a:r>
          </a:p>
        </p:txBody>
      </p:sp>
    </p:spTree>
    <p:extLst>
      <p:ext uri="{BB962C8B-B14F-4D97-AF65-F5344CB8AC3E}">
        <p14:creationId xmlns:p14="http://schemas.microsoft.com/office/powerpoint/2010/main" val="13551153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ontent Placeholder 4">
            <a:extLst>
              <a:ext uri="{FF2B5EF4-FFF2-40B4-BE49-F238E27FC236}">
                <a16:creationId xmlns:a16="http://schemas.microsoft.com/office/drawing/2014/main" id="{03D39663-2D71-E783-B08A-568D1F3285DF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819611701"/>
              </p:ext>
            </p:extLst>
          </p:nvPr>
        </p:nvGraphicFramePr>
        <p:xfrm>
          <a:off x="180974" y="1765167"/>
          <a:ext cx="11877676" cy="3928531"/>
        </p:xfrm>
        <a:graphic>
          <a:graphicData uri="http://schemas.openxmlformats.org/drawingml/2006/table">
            <a:tbl>
              <a:tblPr/>
              <a:tblGrid>
                <a:gridCol w="548641">
                  <a:extLst>
                    <a:ext uri="{9D8B030D-6E8A-4147-A177-3AD203B41FA5}">
                      <a16:colId xmlns:a16="http://schemas.microsoft.com/office/drawing/2014/main" val="3843523335"/>
                    </a:ext>
                  </a:extLst>
                </a:gridCol>
                <a:gridCol w="1188720">
                  <a:extLst>
                    <a:ext uri="{9D8B030D-6E8A-4147-A177-3AD203B41FA5}">
                      <a16:colId xmlns:a16="http://schemas.microsoft.com/office/drawing/2014/main" val="2004636145"/>
                    </a:ext>
                  </a:extLst>
                </a:gridCol>
                <a:gridCol w="662940">
                  <a:extLst>
                    <a:ext uri="{9D8B030D-6E8A-4147-A177-3AD203B41FA5}">
                      <a16:colId xmlns:a16="http://schemas.microsoft.com/office/drawing/2014/main" val="3193082873"/>
                    </a:ext>
                  </a:extLst>
                </a:gridCol>
                <a:gridCol w="1072703">
                  <a:extLst>
                    <a:ext uri="{9D8B030D-6E8A-4147-A177-3AD203B41FA5}">
                      <a16:colId xmlns:a16="http://schemas.microsoft.com/office/drawing/2014/main" val="2517696093"/>
                    </a:ext>
                  </a:extLst>
                </a:gridCol>
                <a:gridCol w="618937">
                  <a:extLst>
                    <a:ext uri="{9D8B030D-6E8A-4147-A177-3AD203B41FA5}">
                      <a16:colId xmlns:a16="http://schemas.microsoft.com/office/drawing/2014/main" val="127256328"/>
                    </a:ext>
                  </a:extLst>
                </a:gridCol>
                <a:gridCol w="1134931">
                  <a:extLst>
                    <a:ext uri="{9D8B030D-6E8A-4147-A177-3AD203B41FA5}">
                      <a16:colId xmlns:a16="http://schemas.microsoft.com/office/drawing/2014/main" val="1394934607"/>
                    </a:ext>
                  </a:extLst>
                </a:gridCol>
                <a:gridCol w="625289">
                  <a:extLst>
                    <a:ext uri="{9D8B030D-6E8A-4147-A177-3AD203B41FA5}">
                      <a16:colId xmlns:a16="http://schemas.microsoft.com/office/drawing/2014/main" val="2443845026"/>
                    </a:ext>
                  </a:extLst>
                </a:gridCol>
                <a:gridCol w="1128579">
                  <a:extLst>
                    <a:ext uri="{9D8B030D-6E8A-4147-A177-3AD203B41FA5}">
                      <a16:colId xmlns:a16="http://schemas.microsoft.com/office/drawing/2014/main" val="3675665379"/>
                    </a:ext>
                  </a:extLst>
                </a:gridCol>
                <a:gridCol w="665931">
                  <a:extLst>
                    <a:ext uri="{9D8B030D-6E8A-4147-A177-3AD203B41FA5}">
                      <a16:colId xmlns:a16="http://schemas.microsoft.com/office/drawing/2014/main" val="1521394110"/>
                    </a:ext>
                  </a:extLst>
                </a:gridCol>
                <a:gridCol w="1183466">
                  <a:extLst>
                    <a:ext uri="{9D8B030D-6E8A-4147-A177-3AD203B41FA5}">
                      <a16:colId xmlns:a16="http://schemas.microsoft.com/office/drawing/2014/main" val="1376684594"/>
                    </a:ext>
                  </a:extLst>
                </a:gridCol>
                <a:gridCol w="565324">
                  <a:extLst>
                    <a:ext uri="{9D8B030D-6E8A-4147-A177-3AD203B41FA5}">
                      <a16:colId xmlns:a16="http://schemas.microsoft.com/office/drawing/2014/main" val="1241484156"/>
                    </a:ext>
                  </a:extLst>
                </a:gridCol>
                <a:gridCol w="1040130">
                  <a:extLst>
                    <a:ext uri="{9D8B030D-6E8A-4147-A177-3AD203B41FA5}">
                      <a16:colId xmlns:a16="http://schemas.microsoft.com/office/drawing/2014/main" val="2628076585"/>
                    </a:ext>
                  </a:extLst>
                </a:gridCol>
                <a:gridCol w="514350">
                  <a:extLst>
                    <a:ext uri="{9D8B030D-6E8A-4147-A177-3AD203B41FA5}">
                      <a16:colId xmlns:a16="http://schemas.microsoft.com/office/drawing/2014/main" val="3478993195"/>
                    </a:ext>
                  </a:extLst>
                </a:gridCol>
                <a:gridCol w="927735">
                  <a:extLst>
                    <a:ext uri="{9D8B030D-6E8A-4147-A177-3AD203B41FA5}">
                      <a16:colId xmlns:a16="http://schemas.microsoft.com/office/drawing/2014/main" val="3942634068"/>
                    </a:ext>
                  </a:extLst>
                </a:gridCol>
              </a:tblGrid>
              <a:tr h="249576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0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TIENT 1</a:t>
                      </a:r>
                    </a:p>
                  </a:txBody>
                  <a:tcPr marL="8181" marR="8181" marT="818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TIENT 2</a:t>
                      </a:r>
                    </a:p>
                  </a:txBody>
                  <a:tcPr marL="8181" marR="8181" marT="818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TIENT 3</a:t>
                      </a:r>
                    </a:p>
                  </a:txBody>
                  <a:tcPr marL="8181" marR="8181" marT="818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TIENT 4</a:t>
                      </a:r>
                    </a:p>
                  </a:txBody>
                  <a:tcPr marL="8181" marR="8181" marT="818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TIENT 5</a:t>
                      </a:r>
                    </a:p>
                  </a:txBody>
                  <a:tcPr marL="8181" marR="8181" marT="818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TIENT 6</a:t>
                      </a:r>
                    </a:p>
                  </a:txBody>
                  <a:tcPr marL="8181" marR="8181" marT="818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VERAGE</a:t>
                      </a:r>
                    </a:p>
                  </a:txBody>
                  <a:tcPr marL="8181" marR="8181" marT="818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5833016"/>
                  </a:ext>
                </a:extLst>
              </a:tr>
              <a:tr h="50861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△ EXPRESSION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△ EXPRESSION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△ EXPRESSION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△ EXPRESSION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△ EXPRESSION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△ EXPRESSION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700" b="0" i="0" u="sng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△ EXPRESSION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5790971"/>
                  </a:ext>
                </a:extLst>
              </a:tr>
              <a:tr h="28821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S3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795.5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2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877.5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0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489.6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0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430.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0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7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04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2.7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9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068.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92281097"/>
                  </a:ext>
                </a:extLst>
              </a:tr>
              <a:tr h="28821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WIST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1.2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3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4.2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5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398.3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9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216.5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7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46.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85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196.6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2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27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5072912"/>
                  </a:ext>
                </a:extLst>
              </a:tr>
              <a:tr h="28821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CNK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06.6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9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4.6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6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195.4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0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38.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2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9.9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8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54.5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96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1097509"/>
                  </a:ext>
                </a:extLst>
              </a:tr>
              <a:tr h="28821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DD4L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7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3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7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2.3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0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0.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7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82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4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5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68786960"/>
                  </a:ext>
                </a:extLst>
              </a:tr>
              <a:tr h="28821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X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7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3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3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7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3.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3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9.4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3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3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4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5822638"/>
                  </a:ext>
                </a:extLst>
              </a:tr>
              <a:tr h="28821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NG4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4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.2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68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176.5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5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.8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7.2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24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70.3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05.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88998310"/>
                  </a:ext>
                </a:extLst>
              </a:tr>
              <a:tr h="28821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CRL3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4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4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3.3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5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6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6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5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92870201"/>
                  </a:ext>
                </a:extLst>
              </a:tr>
              <a:tr h="28821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IGIT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6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2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3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2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572693"/>
                  </a:ext>
                </a:extLst>
              </a:tr>
              <a:tr h="28821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NM3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7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0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.7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57.4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0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13.7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6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5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87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5.4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0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3.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7065664"/>
                  </a:ext>
                </a:extLst>
              </a:tr>
              <a:tr h="28821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T4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3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11.5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9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5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9.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5233645"/>
                  </a:ext>
                </a:extLst>
              </a:tr>
              <a:tr h="28821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TA3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5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5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8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9.4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2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5.8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.4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4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95.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8181" marR="8181" marT="8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92826902"/>
                  </a:ext>
                </a:extLst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80974" y="1248354"/>
            <a:ext cx="919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S2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: Clinical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esponse with treatment.</a:t>
            </a:r>
          </a:p>
        </p:txBody>
      </p:sp>
    </p:spTree>
    <p:extLst>
      <p:ext uri="{BB962C8B-B14F-4D97-AF65-F5344CB8AC3E}">
        <p14:creationId xmlns:p14="http://schemas.microsoft.com/office/powerpoint/2010/main" val="27339222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950</TotalTime>
  <Words>335</Words>
  <Application>Microsoft Office PowerPoint</Application>
  <PresentationFormat>宽屏</PresentationFormat>
  <Paragraphs>235</Paragraphs>
  <Slides>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Supplementary Tables  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for Manuscript  11/28/22</dc:title>
  <dc:creator>Davis, Alanna</dc:creator>
  <cp:lastModifiedBy>MDPI</cp:lastModifiedBy>
  <cp:revision>51</cp:revision>
  <cp:lastPrinted>2023-03-06T19:27:26Z</cp:lastPrinted>
  <dcterms:created xsi:type="dcterms:W3CDTF">2022-11-29T18:46:11Z</dcterms:created>
  <dcterms:modified xsi:type="dcterms:W3CDTF">2026-07-17T07:41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8ca390d5-a4f3-448c-8368-24080179bc53_Enabled">
    <vt:lpwstr>true</vt:lpwstr>
  </property>
  <property fmtid="{D5CDD505-2E9C-101B-9397-08002B2CF9AE}" pid="3" name="MSIP_Label_8ca390d5-a4f3-448c-8368-24080179bc53_SetDate">
    <vt:lpwstr>2023-01-22T21:49:47Z</vt:lpwstr>
  </property>
  <property fmtid="{D5CDD505-2E9C-101B-9397-08002B2CF9AE}" pid="4" name="MSIP_Label_8ca390d5-a4f3-448c-8368-24080179bc53_Method">
    <vt:lpwstr>Standard</vt:lpwstr>
  </property>
  <property fmtid="{D5CDD505-2E9C-101B-9397-08002B2CF9AE}" pid="5" name="MSIP_Label_8ca390d5-a4f3-448c-8368-24080179bc53_Name">
    <vt:lpwstr>Low Risk</vt:lpwstr>
  </property>
  <property fmtid="{D5CDD505-2E9C-101B-9397-08002B2CF9AE}" pid="6" name="MSIP_Label_8ca390d5-a4f3-448c-8368-24080179bc53_SiteId">
    <vt:lpwstr>5b703aa0-061f-4ed9-beca-765a39ee1304</vt:lpwstr>
  </property>
  <property fmtid="{D5CDD505-2E9C-101B-9397-08002B2CF9AE}" pid="7" name="MSIP_Label_8ca390d5-a4f3-448c-8368-24080179bc53_ActionId">
    <vt:lpwstr>f7b76106-d332-4b18-a5af-d49fa91e5ebf</vt:lpwstr>
  </property>
  <property fmtid="{D5CDD505-2E9C-101B-9397-08002B2CF9AE}" pid="8" name="MSIP_Label_8ca390d5-a4f3-448c-8368-24080179bc53_ContentBits">
    <vt:lpwstr>0</vt:lpwstr>
  </property>
</Properties>
</file>